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0" r:id="rId2"/>
    <p:sldId id="257" r:id="rId3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 snapToGrid="0">
      <p:cViewPr varScale="1">
        <p:scale>
          <a:sx n="64" d="100"/>
          <a:sy n="64" d="100"/>
        </p:scale>
        <p:origin x="732" y="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6CC7256-8E27-4F13-9B4B-5C2FD9032517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53DABB7-69C3-49D1-97F7-4E7171BEE193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2CDEE007-4E53-4EDF-A064-67351A5645E3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81AF-16B1-4FA9-A913-33612042372D}" type="datetimeFigureOut">
              <a:rPr lang="en-US" smtClean="0"/>
              <a:t>4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DCCCA2AB-CC08-47D6-B233-352B8D86B3C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352F07A5-4099-4D94-B07E-3B9C44B2983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CB92-743B-4F9D-8385-1213BF3C6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8243489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84EE506-00D9-43A4-9B58-B01DE638023A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DE5B613-30F4-423E-BF13-8A6A7F76541F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BAC6C0C-C7BB-477C-A228-81B1B259F97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81AF-16B1-4FA9-A913-33612042372D}" type="datetimeFigureOut">
              <a:rPr lang="en-US" smtClean="0"/>
              <a:t>4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18F9C56A-B961-4B3A-9BAF-F63C0EA0B36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87D545-BE93-4978-B3B1-8CC238C9DD2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CB92-743B-4F9D-8385-1213BF3C6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7248085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>
            <a:extLst>
              <a:ext uri="{FF2B5EF4-FFF2-40B4-BE49-F238E27FC236}">
                <a16:creationId xmlns:a16="http://schemas.microsoft.com/office/drawing/2014/main" id="{AF5C1D57-0018-4B7B-A3FE-CA40077CCEC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>
            <a:extLst>
              <a:ext uri="{FF2B5EF4-FFF2-40B4-BE49-F238E27FC236}">
                <a16:creationId xmlns:a16="http://schemas.microsoft.com/office/drawing/2014/main" id="{3076CA28-E68D-4BBD-B932-FF8DFB4CFEDC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CD45D87F-B795-40F1-8AC0-141CE310644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81AF-16B1-4FA9-A913-33612042372D}" type="datetimeFigureOut">
              <a:rPr lang="en-US" smtClean="0"/>
              <a:t>4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A2540EA2-870E-438F-8A0A-7E3A686C9A7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043B6A21-0F19-4497-ACBD-38D5EF4842F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CB92-743B-4F9D-8385-1213BF3C6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15041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F3189F-A191-4923-981D-21868359F2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884F6196-008B-4D20-9BFC-23BDA220DEA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42D89E6-0BD4-43DC-94E9-AA22B6F4129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81AF-16B1-4FA9-A913-33612042372D}" type="datetimeFigureOut">
              <a:rPr lang="en-US" smtClean="0"/>
              <a:t>4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4DE9917F-1F9E-408B-863E-E94A2AC880A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94A72D6C-0D4A-4A67-8136-5245B0E1530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CB92-743B-4F9D-8385-1213BF3C6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2741435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F50A39F-0275-4326-A11D-8821C75FB057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451D814-D5BF-4F9A-8268-32418160FC1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602DBD55-2446-4DD2-8004-4D9451CA0E7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81AF-16B1-4FA9-A913-33612042372D}" type="datetimeFigureOut">
              <a:rPr lang="en-US" smtClean="0"/>
              <a:t>4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FEA66FCE-58B3-432E-8352-57020EB554B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D1086A10-0107-4922-AAB7-A35B01966323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CB92-743B-4F9D-8385-1213BF3C6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9134028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8FA1D619-F07B-4BBF-B7BF-F18EE573CC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2EE8B493-2546-46E5-BB96-2735C9F1B0AF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C53F5707-12CD-40A8-9179-BC3D657ECAD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E54289C5-756C-47D2-9A83-5C3BCA09DDFC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81AF-16B1-4FA9-A913-33612042372D}" type="datetimeFigureOut">
              <a:rPr lang="en-US" smtClean="0"/>
              <a:t>4/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3A0705C-E8B1-4E09-8313-1EEE5DB8EFC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03AF324-A2CB-44A6-ABA5-6F244C5D8E5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CB92-743B-4F9D-8385-1213BF3C6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0846025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3787411A-11BF-4D0A-8A34-08BF76BFF9E6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269F5FAA-C011-4FCB-ADA4-1EF55D818E5D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>
            <a:extLst>
              <a:ext uri="{FF2B5EF4-FFF2-40B4-BE49-F238E27FC236}">
                <a16:creationId xmlns:a16="http://schemas.microsoft.com/office/drawing/2014/main" id="{AE74F95E-7C73-40F6-B448-2B05B982A1B3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>
            <a:extLst>
              <a:ext uri="{FF2B5EF4-FFF2-40B4-BE49-F238E27FC236}">
                <a16:creationId xmlns:a16="http://schemas.microsoft.com/office/drawing/2014/main" id="{1B5904BE-60B5-424F-A2B9-1C5E767E47F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>
            <a:extLst>
              <a:ext uri="{FF2B5EF4-FFF2-40B4-BE49-F238E27FC236}">
                <a16:creationId xmlns:a16="http://schemas.microsoft.com/office/drawing/2014/main" id="{1421A3E8-14EB-4CF5-9DD5-F1F8C5B4DF98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>
            <a:extLst>
              <a:ext uri="{FF2B5EF4-FFF2-40B4-BE49-F238E27FC236}">
                <a16:creationId xmlns:a16="http://schemas.microsoft.com/office/drawing/2014/main" id="{787BDAD0-3E5B-4C02-A78F-12D2F71F4D9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81AF-16B1-4FA9-A913-33612042372D}" type="datetimeFigureOut">
              <a:rPr lang="en-US" smtClean="0"/>
              <a:t>4/2/2021</a:t>
            </a:fld>
            <a:endParaRPr lang="en-US"/>
          </a:p>
        </p:txBody>
      </p:sp>
      <p:sp>
        <p:nvSpPr>
          <p:cNvPr id="8" name="Footer Placeholder 7">
            <a:extLst>
              <a:ext uri="{FF2B5EF4-FFF2-40B4-BE49-F238E27FC236}">
                <a16:creationId xmlns:a16="http://schemas.microsoft.com/office/drawing/2014/main" id="{60F180D1-8260-481B-8101-B8B6EA991D4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>
            <a:extLst>
              <a:ext uri="{FF2B5EF4-FFF2-40B4-BE49-F238E27FC236}">
                <a16:creationId xmlns:a16="http://schemas.microsoft.com/office/drawing/2014/main" id="{2A9386A2-4936-4D91-961D-CE8B98A45E7C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CB92-743B-4F9D-8385-1213BF3C6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86548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9CD92FF5-9988-4F45-A66B-BBA018D5B22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>
            <a:extLst>
              <a:ext uri="{FF2B5EF4-FFF2-40B4-BE49-F238E27FC236}">
                <a16:creationId xmlns:a16="http://schemas.microsoft.com/office/drawing/2014/main" id="{250CE23A-3EA2-4ADF-9C17-A2FC96F0B76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81AF-16B1-4FA9-A913-33612042372D}" type="datetimeFigureOut">
              <a:rPr lang="en-US" smtClean="0"/>
              <a:t>4/2/2021</a:t>
            </a:fld>
            <a:endParaRPr lang="en-US"/>
          </a:p>
        </p:txBody>
      </p:sp>
      <p:sp>
        <p:nvSpPr>
          <p:cNvPr id="4" name="Footer Placeholder 3">
            <a:extLst>
              <a:ext uri="{FF2B5EF4-FFF2-40B4-BE49-F238E27FC236}">
                <a16:creationId xmlns:a16="http://schemas.microsoft.com/office/drawing/2014/main" id="{143A48C4-F1EE-4CFD-A869-EA22702E979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>
            <a:extLst>
              <a:ext uri="{FF2B5EF4-FFF2-40B4-BE49-F238E27FC236}">
                <a16:creationId xmlns:a16="http://schemas.microsoft.com/office/drawing/2014/main" id="{6ADDAFE2-9E87-4CF3-944E-B5A794F35D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CB92-743B-4F9D-8385-1213BF3C6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51702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>
            <a:extLst>
              <a:ext uri="{FF2B5EF4-FFF2-40B4-BE49-F238E27FC236}">
                <a16:creationId xmlns:a16="http://schemas.microsoft.com/office/drawing/2014/main" id="{8F376CE2-A092-4567-923C-F049493FADB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81AF-16B1-4FA9-A913-33612042372D}" type="datetimeFigureOut">
              <a:rPr lang="en-US" smtClean="0"/>
              <a:t>4/2/2021</a:t>
            </a:fld>
            <a:endParaRPr lang="en-US"/>
          </a:p>
        </p:txBody>
      </p:sp>
      <p:sp>
        <p:nvSpPr>
          <p:cNvPr id="3" name="Footer Placeholder 2">
            <a:extLst>
              <a:ext uri="{FF2B5EF4-FFF2-40B4-BE49-F238E27FC236}">
                <a16:creationId xmlns:a16="http://schemas.microsoft.com/office/drawing/2014/main" id="{176289C6-12D6-4358-8309-DB856E52436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>
            <a:extLst>
              <a:ext uri="{FF2B5EF4-FFF2-40B4-BE49-F238E27FC236}">
                <a16:creationId xmlns:a16="http://schemas.microsoft.com/office/drawing/2014/main" id="{66D746D2-42CF-43C8-A404-F57EA599FC5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CB92-743B-4F9D-8385-1213BF3C6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9512570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BE8B45B-3960-42AC-93C3-B6953595565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6F0F2A0-F688-47D8-A053-1B6A75FB5EF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A507F804-3ED4-45C8-82AC-4316801F0EA8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5A29B906-743E-4D0E-B559-20A6754582B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81AF-16B1-4FA9-A913-33612042372D}" type="datetimeFigureOut">
              <a:rPr lang="en-US" smtClean="0"/>
              <a:t>4/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02565249-25EB-4765-ABF4-88A7C1EABD7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BDFC6C06-7277-4682-A913-E493670AA4C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CB92-743B-4F9D-8385-1213BF3C6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9213130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48EA9C3-0978-4430-AE20-1F306CC0700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>
            <a:extLst>
              <a:ext uri="{FF2B5EF4-FFF2-40B4-BE49-F238E27FC236}">
                <a16:creationId xmlns:a16="http://schemas.microsoft.com/office/drawing/2014/main" id="{AA51D6FA-3F88-4FCA-873B-82046332039B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>
            <a:extLst>
              <a:ext uri="{FF2B5EF4-FFF2-40B4-BE49-F238E27FC236}">
                <a16:creationId xmlns:a16="http://schemas.microsoft.com/office/drawing/2014/main" id="{49D51EB8-B391-4130-ACA5-51605FF792BF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>
            <a:extLst>
              <a:ext uri="{FF2B5EF4-FFF2-40B4-BE49-F238E27FC236}">
                <a16:creationId xmlns:a16="http://schemas.microsoft.com/office/drawing/2014/main" id="{37D9EAC4-7B5C-47D4-B306-C589A14651A9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12D81AF-16B1-4FA9-A913-33612042372D}" type="datetimeFigureOut">
              <a:rPr lang="en-US" smtClean="0"/>
              <a:t>4/2/2021</a:t>
            </a:fld>
            <a:endParaRPr lang="en-US"/>
          </a:p>
        </p:txBody>
      </p:sp>
      <p:sp>
        <p:nvSpPr>
          <p:cNvPr id="6" name="Footer Placeholder 5">
            <a:extLst>
              <a:ext uri="{FF2B5EF4-FFF2-40B4-BE49-F238E27FC236}">
                <a16:creationId xmlns:a16="http://schemas.microsoft.com/office/drawing/2014/main" id="{44258286-300A-4FF9-AFA4-50CDE7E03C7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>
            <a:extLst>
              <a:ext uri="{FF2B5EF4-FFF2-40B4-BE49-F238E27FC236}">
                <a16:creationId xmlns:a16="http://schemas.microsoft.com/office/drawing/2014/main" id="{D6C3E940-7320-4D0D-9CB1-CC63510A831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EADCB92-743B-4F9D-8385-1213BF3C6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21668684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>
            <a:extLst>
              <a:ext uri="{FF2B5EF4-FFF2-40B4-BE49-F238E27FC236}">
                <a16:creationId xmlns:a16="http://schemas.microsoft.com/office/drawing/2014/main" id="{B1857DBE-1390-45B0-AD4C-BF4A56CB120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>
            <a:extLst>
              <a:ext uri="{FF2B5EF4-FFF2-40B4-BE49-F238E27FC236}">
                <a16:creationId xmlns:a16="http://schemas.microsoft.com/office/drawing/2014/main" id="{52039D1F-C195-400A-BA53-45988AECC12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>
            <a:extLst>
              <a:ext uri="{FF2B5EF4-FFF2-40B4-BE49-F238E27FC236}">
                <a16:creationId xmlns:a16="http://schemas.microsoft.com/office/drawing/2014/main" id="{8F08A82E-97B3-4552-B27A-40A30515679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12D81AF-16B1-4FA9-A913-33612042372D}" type="datetimeFigureOut">
              <a:rPr lang="en-US" smtClean="0"/>
              <a:t>4/2/2021</a:t>
            </a:fld>
            <a:endParaRPr lang="en-US"/>
          </a:p>
        </p:txBody>
      </p:sp>
      <p:sp>
        <p:nvSpPr>
          <p:cNvPr id="5" name="Footer Placeholder 4">
            <a:extLst>
              <a:ext uri="{FF2B5EF4-FFF2-40B4-BE49-F238E27FC236}">
                <a16:creationId xmlns:a16="http://schemas.microsoft.com/office/drawing/2014/main" id="{52C18BC6-936B-48BB-9502-445CA5614B5F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>
            <a:extLst>
              <a:ext uri="{FF2B5EF4-FFF2-40B4-BE49-F238E27FC236}">
                <a16:creationId xmlns:a16="http://schemas.microsoft.com/office/drawing/2014/main" id="{6C018464-C805-405D-A90C-1004B616B173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EADCB92-743B-4F9D-8385-1213BF3C6AEC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99394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tif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>
            <a:extLst>
              <a:ext uri="{FF2B5EF4-FFF2-40B4-BE49-F238E27FC236}">
                <a16:creationId xmlns:a16="http://schemas.microsoft.com/office/drawing/2014/main" id="{05806471-DD43-4C2E-BCEC-26AB07FB620A}"/>
              </a:ext>
            </a:extLst>
          </p:cNvPr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97653" y="-30581"/>
            <a:ext cx="7911151" cy="5834702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0B65049F-31B7-4AD4-908C-91FD39D64BDC}"/>
              </a:ext>
            </a:extLst>
          </p:cNvPr>
          <p:cNvSpPr txBox="1"/>
          <p:nvPr/>
        </p:nvSpPr>
        <p:spPr>
          <a:xfrm>
            <a:off x="2453140" y="5380672"/>
            <a:ext cx="8717658" cy="147732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umber at risk       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CD74-ROS1: 90                         16                           0                          0</a:t>
            </a:r>
            <a:endParaRPr lang="en-US" altLang="zh-CN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SDC-ROS1:   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23                         9                            1                           0               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EZR-ROS1:   21                         7                             0                           0  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Other:            25                        13                            0                           0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id="{AEFCEDDB-48DB-4D4B-9955-9FFEE5F151CD}"/>
              </a:ext>
            </a:extLst>
          </p:cNvPr>
          <p:cNvSpPr txBox="1"/>
          <p:nvPr/>
        </p:nvSpPr>
        <p:spPr>
          <a:xfrm>
            <a:off x="0" y="94422"/>
            <a:ext cx="2007704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>
              <a:defRPr sz="2400">
                <a:latin typeface="Arial" panose="020B0604020202020204" pitchFamily="34" charset="0"/>
                <a:cs typeface="Arial" panose="020B0604020202020204" pitchFamily="34" charset="0"/>
              </a:defRPr>
            </a:lvl1pPr>
          </a:lstStyle>
          <a:p>
            <a:r>
              <a:rPr lang="en-US" dirty="0"/>
              <a:t>Figure S1 A</a:t>
            </a:r>
          </a:p>
        </p:txBody>
      </p:sp>
    </p:spTree>
    <p:extLst>
      <p:ext uri="{BB962C8B-B14F-4D97-AF65-F5344CB8AC3E}">
        <p14:creationId xmlns:p14="http://schemas.microsoft.com/office/powerpoint/2010/main" val="28250060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>
            <a:extLst>
              <a:ext uri="{FF2B5EF4-FFF2-40B4-BE49-F238E27FC236}">
                <a16:creationId xmlns:a16="http://schemas.microsoft.com/office/drawing/2014/main" id="{B7FFD4EB-ABF4-4C72-B144-492F96A0C6A5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882900" y="0"/>
            <a:ext cx="8163059" cy="5675645"/>
          </a:xfrm>
          <a:prstGeom prst="rect">
            <a:avLst/>
          </a:prstGeom>
        </p:spPr>
      </p:pic>
      <p:sp>
        <p:nvSpPr>
          <p:cNvPr id="3" name="TextBox 2">
            <a:extLst>
              <a:ext uri="{FF2B5EF4-FFF2-40B4-BE49-F238E27FC236}">
                <a16:creationId xmlns:a16="http://schemas.microsoft.com/office/drawing/2014/main" id="{9F969E63-73D1-4E78-BAAC-DD57FB8CD2E5}"/>
              </a:ext>
            </a:extLst>
          </p:cNvPr>
          <p:cNvSpPr txBox="1"/>
          <p:nvPr/>
        </p:nvSpPr>
        <p:spPr>
          <a:xfrm>
            <a:off x="2008725" y="5281573"/>
            <a:ext cx="8407483" cy="92333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Number at risk       </a:t>
            </a:r>
          </a:p>
          <a:p>
            <a:r>
              <a:rPr lang="en-US" altLang="zh-CN" dirty="0" err="1">
                <a:latin typeface="Arial" panose="020B0604020202020204" pitchFamily="34" charset="0"/>
                <a:cs typeface="Arial" panose="020B0604020202020204" pitchFamily="34" charset="0"/>
              </a:rPr>
              <a:t>n</a:t>
            </a:r>
            <a:r>
              <a:rPr lang="en-US" dirty="0" err="1">
                <a:latin typeface="Arial" panose="020B0604020202020204" pitchFamily="34" charset="0"/>
                <a:cs typeface="Arial" panose="020B0604020202020204" pitchFamily="34" charset="0"/>
              </a:rPr>
              <a:t>R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/R </a:t>
            </a:r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Translocation</a:t>
            </a:r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:  9                            4                             0                             0               </a:t>
            </a:r>
          </a:p>
          <a:p>
            <a:r>
              <a:rPr lang="en-US" dirty="0">
                <a:latin typeface="Arial" panose="020B0604020202020204" pitchFamily="34" charset="0"/>
                <a:cs typeface="Arial" panose="020B0604020202020204" pitchFamily="34" charset="0"/>
              </a:rPr>
              <a:t>Single ROS1 fusion:  159                       45                           1                             0     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A0CCE360-622B-4DA0-9B8F-A9DBCA8C34F9}"/>
              </a:ext>
            </a:extLst>
          </p:cNvPr>
          <p:cNvSpPr txBox="1"/>
          <p:nvPr/>
        </p:nvSpPr>
        <p:spPr>
          <a:xfrm>
            <a:off x="0" y="94422"/>
            <a:ext cx="1928191" cy="46166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2400" dirty="0">
                <a:latin typeface="Arial" panose="020B0604020202020204" pitchFamily="34" charset="0"/>
                <a:cs typeface="Arial" panose="020B0604020202020204" pitchFamily="34" charset="0"/>
              </a:rPr>
              <a:t>Figure S1 B</a:t>
            </a:r>
            <a:endParaRPr lang="en-US" sz="24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23930779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4</TotalTime>
  <Words>53</Words>
  <Application>Microsoft Office PowerPoint</Application>
  <PresentationFormat>Widescreen</PresentationFormat>
  <Paragraphs>10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6" baseType="lpstr">
      <vt:lpstr>Arial</vt:lpstr>
      <vt:lpstr>Calibri</vt:lpstr>
      <vt:lpstr>Calibri Light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Zhang Yongchang</dc:creator>
  <cp:lastModifiedBy>Zhang Yongchang</cp:lastModifiedBy>
  <cp:revision>4</cp:revision>
  <dcterms:created xsi:type="dcterms:W3CDTF">2021-01-17T07:41:06Z</dcterms:created>
  <dcterms:modified xsi:type="dcterms:W3CDTF">2021-04-02T10:53:18Z</dcterms:modified>
</cp:coreProperties>
</file>